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2" saveSubsetFonts="1">
  <p:sldMasterIdLst>
    <p:sldMasterId id="2147483672" r:id="rId4"/>
  </p:sldMasterIdLst>
  <p:sldIdLst>
    <p:sldId id="265" r:id="rId5"/>
    <p:sldId id="269" r:id="rId6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F2D6721-8DD9-43AD-7C2B-6EDF57016B70}" name="Colin Selman" initials="CS" userId="S::Colin.Selman@glasgow.ac.uk::814c9d20-62fb-4172-9817-60f50dfb4b12" providerId="AD"/>
  <p188:author id="{225B5ACE-853D-755B-989C-FF75EE7F6E8C}" name="Gillian Borland" initials="GB" userId="S::gillian.borland@glasgow.ac.uk::6fa19246-7eee-4e6e-a5d0-6986a9d96b9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0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olin Selman" userId="814c9d20-62fb-4172-9817-60f50dfb4b12" providerId="ADAL" clId="{AC78B20B-922C-4D2E-8ACE-917C2A37CEEA}"/>
    <pc:docChg chg="delSld">
      <pc:chgData name="Colin Selman" userId="814c9d20-62fb-4172-9817-60f50dfb4b12" providerId="ADAL" clId="{AC78B20B-922C-4D2E-8ACE-917C2A37CEEA}" dt="2023-10-18T19:12:22.967" v="6" actId="47"/>
      <pc:docMkLst>
        <pc:docMk/>
      </pc:docMkLst>
      <pc:sldChg chg="del">
        <pc:chgData name="Colin Selman" userId="814c9d20-62fb-4172-9817-60f50dfb4b12" providerId="ADAL" clId="{AC78B20B-922C-4D2E-8ACE-917C2A37CEEA}" dt="2023-10-18T19:12:15.695" v="0" actId="47"/>
        <pc:sldMkLst>
          <pc:docMk/>
          <pc:sldMk cId="2822815551" sldId="256"/>
        </pc:sldMkLst>
      </pc:sldChg>
      <pc:sldChg chg="del">
        <pc:chgData name="Colin Selman" userId="814c9d20-62fb-4172-9817-60f50dfb4b12" providerId="ADAL" clId="{AC78B20B-922C-4D2E-8ACE-917C2A37CEEA}" dt="2023-10-18T19:12:16.750" v="1" actId="47"/>
        <pc:sldMkLst>
          <pc:docMk/>
          <pc:sldMk cId="1838440358" sldId="257"/>
        </pc:sldMkLst>
      </pc:sldChg>
      <pc:sldChg chg="del">
        <pc:chgData name="Colin Selman" userId="814c9d20-62fb-4172-9817-60f50dfb4b12" providerId="ADAL" clId="{AC78B20B-922C-4D2E-8ACE-917C2A37CEEA}" dt="2023-10-18T19:12:18.376" v="2" actId="47"/>
        <pc:sldMkLst>
          <pc:docMk/>
          <pc:sldMk cId="3508757016" sldId="261"/>
        </pc:sldMkLst>
      </pc:sldChg>
      <pc:sldChg chg="del">
        <pc:chgData name="Colin Selman" userId="814c9d20-62fb-4172-9817-60f50dfb4b12" providerId="ADAL" clId="{AC78B20B-922C-4D2E-8ACE-917C2A37CEEA}" dt="2023-10-18T19:12:21.129" v="5" actId="47"/>
        <pc:sldMkLst>
          <pc:docMk/>
          <pc:sldMk cId="462813777" sldId="266"/>
        </pc:sldMkLst>
      </pc:sldChg>
      <pc:sldChg chg="del">
        <pc:chgData name="Colin Selman" userId="814c9d20-62fb-4172-9817-60f50dfb4b12" providerId="ADAL" clId="{AC78B20B-922C-4D2E-8ACE-917C2A37CEEA}" dt="2023-10-18T19:12:19.272" v="3" actId="47"/>
        <pc:sldMkLst>
          <pc:docMk/>
          <pc:sldMk cId="744127856" sldId="267"/>
        </pc:sldMkLst>
      </pc:sldChg>
      <pc:sldChg chg="del">
        <pc:chgData name="Colin Selman" userId="814c9d20-62fb-4172-9817-60f50dfb4b12" providerId="ADAL" clId="{AC78B20B-922C-4D2E-8ACE-917C2A37CEEA}" dt="2023-10-18T19:12:20.206" v="4" actId="47"/>
        <pc:sldMkLst>
          <pc:docMk/>
          <pc:sldMk cId="1169514290" sldId="268"/>
        </pc:sldMkLst>
      </pc:sldChg>
      <pc:sldChg chg="del">
        <pc:chgData name="Colin Selman" userId="814c9d20-62fb-4172-9817-60f50dfb4b12" providerId="ADAL" clId="{AC78B20B-922C-4D2E-8ACE-917C2A37CEEA}" dt="2023-10-18T19:12:22.967" v="6" actId="47"/>
        <pc:sldMkLst>
          <pc:docMk/>
          <pc:sldMk cId="3695358151" sldId="27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1008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6973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2915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7406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4444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8634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5503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9915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2057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2400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528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9159D-7C2D-440F-AE21-18599BED2CB8}" type="datetimeFigureOut">
              <a:rPr lang="en-GB" smtClean="0"/>
              <a:t>18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1A6538-A90E-4F65-B923-FD76DF06AA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8166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ubtitle 2">
            <a:extLst>
              <a:ext uri="{FF2B5EF4-FFF2-40B4-BE49-F238E27FC236}">
                <a16:creationId xmlns:a16="http://schemas.microsoft.com/office/drawing/2014/main" id="{B158D610-8D67-D99D-4FE6-1AE901169051}"/>
              </a:ext>
            </a:extLst>
          </p:cNvPr>
          <p:cNvSpPr txBox="1">
            <a:spLocks/>
          </p:cNvSpPr>
          <p:nvPr/>
        </p:nvSpPr>
        <p:spPr>
          <a:xfrm>
            <a:off x="1005181" y="4544751"/>
            <a:ext cx="9809527" cy="1655762"/>
          </a:xfrm>
          <a:prstGeom prst="rect">
            <a:avLst/>
          </a:prstGeom>
        </p:spPr>
        <p:txBody>
          <a:bodyPr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en-GB" sz="18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Lifespan in days for wild-type (WT) and </a:t>
            </a:r>
            <a:r>
              <a:rPr lang="en-GB" sz="1800" i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olr3b</a:t>
            </a:r>
            <a:r>
              <a:rPr lang="en-GB" sz="1800" i="1" baseline="30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+/- </a:t>
            </a:r>
            <a:r>
              <a:rPr lang="en-GB" sz="18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ice. Oldest (or youngest) 10% are the mean lifespan of the longest (or shortest) living 10% of animals within a genotype. N= Sample size</a:t>
            </a:r>
            <a:endParaRPr lang="en-GB" sz="1800" b="1" dirty="0"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en-GB" sz="1800" dirty="0"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8542FD1-933C-70BE-40F3-5060EDBF6B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4321901"/>
              </p:ext>
            </p:extLst>
          </p:nvPr>
        </p:nvGraphicFramePr>
        <p:xfrm>
          <a:off x="1119337" y="1710338"/>
          <a:ext cx="10067776" cy="221375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257117">
                  <a:extLst>
                    <a:ext uri="{9D8B030D-6E8A-4147-A177-3AD203B41FA5}">
                      <a16:colId xmlns:a16="http://schemas.microsoft.com/office/drawing/2014/main" val="3792117249"/>
                    </a:ext>
                  </a:extLst>
                </a:gridCol>
                <a:gridCol w="1257117">
                  <a:extLst>
                    <a:ext uri="{9D8B030D-6E8A-4147-A177-3AD203B41FA5}">
                      <a16:colId xmlns:a16="http://schemas.microsoft.com/office/drawing/2014/main" val="1550023488"/>
                    </a:ext>
                  </a:extLst>
                </a:gridCol>
                <a:gridCol w="1257117">
                  <a:extLst>
                    <a:ext uri="{9D8B030D-6E8A-4147-A177-3AD203B41FA5}">
                      <a16:colId xmlns:a16="http://schemas.microsoft.com/office/drawing/2014/main" val="1890853229"/>
                    </a:ext>
                  </a:extLst>
                </a:gridCol>
                <a:gridCol w="1260008">
                  <a:extLst>
                    <a:ext uri="{9D8B030D-6E8A-4147-A177-3AD203B41FA5}">
                      <a16:colId xmlns:a16="http://schemas.microsoft.com/office/drawing/2014/main" val="1278698610"/>
                    </a:ext>
                  </a:extLst>
                </a:gridCol>
                <a:gridCol w="1260008">
                  <a:extLst>
                    <a:ext uri="{9D8B030D-6E8A-4147-A177-3AD203B41FA5}">
                      <a16:colId xmlns:a16="http://schemas.microsoft.com/office/drawing/2014/main" val="2662071750"/>
                    </a:ext>
                  </a:extLst>
                </a:gridCol>
                <a:gridCol w="1257839">
                  <a:extLst>
                    <a:ext uri="{9D8B030D-6E8A-4147-A177-3AD203B41FA5}">
                      <a16:colId xmlns:a16="http://schemas.microsoft.com/office/drawing/2014/main" val="782932391"/>
                    </a:ext>
                  </a:extLst>
                </a:gridCol>
                <a:gridCol w="1259285">
                  <a:extLst>
                    <a:ext uri="{9D8B030D-6E8A-4147-A177-3AD203B41FA5}">
                      <a16:colId xmlns:a16="http://schemas.microsoft.com/office/drawing/2014/main" val="3351030575"/>
                    </a:ext>
                  </a:extLst>
                </a:gridCol>
                <a:gridCol w="1259285">
                  <a:extLst>
                    <a:ext uri="{9D8B030D-6E8A-4147-A177-3AD203B41FA5}">
                      <a16:colId xmlns:a16="http://schemas.microsoft.com/office/drawing/2014/main" val="914759466"/>
                    </a:ext>
                  </a:extLst>
                </a:gridCol>
              </a:tblGrid>
              <a:tr h="737920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12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lifespan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</a:t>
                      </a:r>
                      <a:r>
                        <a:rPr lang="en-GB" sz="12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fespan</a:t>
                      </a:r>
                      <a:r>
                        <a:rPr lang="en-GB" sz="12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12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ge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oungest 10% Mean </a:t>
                      </a:r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dest 10% </a:t>
                      </a:r>
                      <a:r>
                        <a:rPr lang="en-GB" sz="12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GB" sz="12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M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9423257"/>
                  </a:ext>
                </a:extLst>
              </a:tr>
              <a:tr h="245973">
                <a:tc rowSpan="2"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bined sexes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3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1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1-1032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1</a:t>
                      </a:r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2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9449454"/>
                  </a:ext>
                </a:extLst>
              </a:tr>
              <a:tr h="2459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r3b</a:t>
                      </a:r>
                      <a:r>
                        <a:rPr lang="en-GB" sz="120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-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1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2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-1040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4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4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7562979"/>
                  </a:ext>
                </a:extLst>
              </a:tr>
              <a:tr h="245973">
                <a:tc rowSpan="2"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5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9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5-995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4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8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0920496"/>
                  </a:ext>
                </a:extLst>
              </a:tr>
              <a:tr h="2459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r3b</a:t>
                      </a:r>
                      <a:r>
                        <a:rPr lang="en-GB" sz="1200" baseline="30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-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3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8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5-984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2</a:t>
                      </a:r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1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6041198"/>
                  </a:ext>
                </a:extLst>
              </a:tr>
              <a:tr h="245973">
                <a:tc rowSpan="2"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GB" sz="12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3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4</a:t>
                      </a:r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1-1032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2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0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4536214"/>
                  </a:ext>
                </a:extLst>
              </a:tr>
              <a:tr h="24597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r3b</a:t>
                      </a:r>
                      <a:r>
                        <a:rPr lang="en-GB" sz="1200" baseline="30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-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4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6</a:t>
                      </a:r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-1040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6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5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</a:t>
                      </a:r>
                      <a:r>
                        <a:rPr lang="en-GB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173598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B25F03B-C23B-D315-4DF3-8705CC0AE929}"/>
              </a:ext>
            </a:extLst>
          </p:cNvPr>
          <p:cNvSpPr txBox="1"/>
          <p:nvPr/>
        </p:nvSpPr>
        <p:spPr>
          <a:xfrm>
            <a:off x="209725" y="285226"/>
            <a:ext cx="8020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Table S1: </a:t>
            </a:r>
            <a:r>
              <a:rPr lang="en-GB" sz="1800" b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omparative survival characteristics of WT and </a:t>
            </a:r>
            <a:r>
              <a:rPr lang="en-GB" sz="1800" b="1" i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olr3b</a:t>
            </a:r>
            <a:r>
              <a:rPr lang="en-GB" sz="1800" b="1" i="1" baseline="30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+/-</a:t>
            </a:r>
            <a:r>
              <a:rPr lang="en-GB" sz="1800" b="1" i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sz="1800" b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ice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3468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7614334-406E-FC98-3F15-E8F11102B06D}"/>
              </a:ext>
            </a:extLst>
          </p:cNvPr>
          <p:cNvSpPr txBox="1"/>
          <p:nvPr/>
        </p:nvSpPr>
        <p:spPr>
          <a:xfrm>
            <a:off x="441199" y="470871"/>
            <a:ext cx="3194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2 Primer Sequences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0CD19EF6-8F18-2C58-2CE3-4CF6529366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6288199"/>
              </p:ext>
            </p:extLst>
          </p:nvPr>
        </p:nvGraphicFramePr>
        <p:xfrm>
          <a:off x="2508307" y="2561960"/>
          <a:ext cx="6828638" cy="1402401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913846">
                  <a:extLst>
                    <a:ext uri="{9D8B030D-6E8A-4147-A177-3AD203B41FA5}">
                      <a16:colId xmlns:a16="http://schemas.microsoft.com/office/drawing/2014/main" val="492621195"/>
                    </a:ext>
                  </a:extLst>
                </a:gridCol>
                <a:gridCol w="889424">
                  <a:extLst>
                    <a:ext uri="{9D8B030D-6E8A-4147-A177-3AD203B41FA5}">
                      <a16:colId xmlns:a16="http://schemas.microsoft.com/office/drawing/2014/main" val="2017690123"/>
                    </a:ext>
                  </a:extLst>
                </a:gridCol>
                <a:gridCol w="2569012">
                  <a:extLst>
                    <a:ext uri="{9D8B030D-6E8A-4147-A177-3AD203B41FA5}">
                      <a16:colId xmlns:a16="http://schemas.microsoft.com/office/drawing/2014/main" val="2656112988"/>
                    </a:ext>
                  </a:extLst>
                </a:gridCol>
                <a:gridCol w="2456356">
                  <a:extLst>
                    <a:ext uri="{9D8B030D-6E8A-4147-A177-3AD203B41FA5}">
                      <a16:colId xmlns:a16="http://schemas.microsoft.com/office/drawing/2014/main" val="252581456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ose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923611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typing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r3b WT 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AGGCTGCTGTGCACTGTATT-3’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ACGGCACTGGAGCAGAAT-3’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630344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typing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r3b KO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TCAGTGGGGAAAGTTCAGGC-3’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TCAGACGGACACTGGACACT-3’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493092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-qPCR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2M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ATGGCTCGCTCGGTGAC-3’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AGTTCAGTATGTTCGGCTTCC-3’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2452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-qPCR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BS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TGAGGGTGATTCGAGTGGG-3’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TGTCTCCCGTGGTGGACATA-3’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016275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-qPCR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WHAZ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AAAAGTTCTTGATCCCCAATGC-3’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TGACTGGTCCACAATTCCTT-3’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3802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-qPCR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r3b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TGGAGCCTCAGTTACCAGC-3’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AATCGACCCTGTTTCACGG-3’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00771611"/>
                  </a:ext>
                </a:extLst>
              </a:tr>
            </a:tbl>
          </a:graphicData>
        </a:graphic>
      </p:graphicFrame>
      <p:sp>
        <p:nvSpPr>
          <p:cNvPr id="2" name="Subtitle 2">
            <a:extLst>
              <a:ext uri="{FF2B5EF4-FFF2-40B4-BE49-F238E27FC236}">
                <a16:creationId xmlns:a16="http://schemas.microsoft.com/office/drawing/2014/main" id="{8B34D705-03F6-D0F2-D790-9911A24163FB}"/>
              </a:ext>
            </a:extLst>
          </p:cNvPr>
          <p:cNvSpPr txBox="1">
            <a:spLocks/>
          </p:cNvSpPr>
          <p:nvPr/>
        </p:nvSpPr>
        <p:spPr>
          <a:xfrm>
            <a:off x="1268036" y="4418700"/>
            <a:ext cx="9809527" cy="752463"/>
          </a:xfrm>
          <a:prstGeom prst="rect">
            <a:avLst/>
          </a:prstGeom>
        </p:spPr>
        <p:txBody>
          <a:bodyPr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00000"/>
              </a:lnSpc>
              <a:spcAft>
                <a:spcPts val="800"/>
              </a:spcAft>
              <a:buNone/>
            </a:pPr>
            <a:r>
              <a:rPr lang="en-GB" sz="18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bbreviations: B2M: Beta-2-microglobulin; HMBS: Hydroxymethylbilane synthase; YWHAZ: </a:t>
            </a:r>
            <a:r>
              <a:rPr lang="en-GB" sz="1800" b="0" i="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yrosine 3-Monooxygenase/Tryptophan 5-Monooxygenase Activation Protein Zeta</a:t>
            </a:r>
            <a:endParaRPr lang="en-GB" sz="1800" dirty="0"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7276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22793d5-3ed3-4929-8744-ffb85abedb4b" xsi:nil="true"/>
    <lcf76f155ced4ddcb4097134ff3c332f xmlns="80a5973c-c1b7-4316-8b87-a29795785b25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C5E1FE38DA6544EBCD92531E80C1992" ma:contentTypeVersion="17" ma:contentTypeDescription="Create a new document." ma:contentTypeScope="" ma:versionID="97f289b17692828bf11e1a2dd9f85cd8">
  <xsd:schema xmlns:xsd="http://www.w3.org/2001/XMLSchema" xmlns:xs="http://www.w3.org/2001/XMLSchema" xmlns:p="http://schemas.microsoft.com/office/2006/metadata/properties" xmlns:ns2="80a5973c-c1b7-4316-8b87-a29795785b25" xmlns:ns3="422793d5-3ed3-4929-8744-ffb85abedb4b" targetNamespace="http://schemas.microsoft.com/office/2006/metadata/properties" ma:root="true" ma:fieldsID="579f99a7b84045f15e717956ae2a6907" ns2:_="" ns3:_="">
    <xsd:import namespace="80a5973c-c1b7-4316-8b87-a29795785b25"/>
    <xsd:import namespace="422793d5-3ed3-4929-8744-ffb85abedb4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2:MediaServiceObjectDetectorVersions" minOccurs="0"/>
                <xsd:element ref="ns2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0a5973c-c1b7-4316-8b87-a29795785b2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20" nillable="true" ma:taxonomy="true" ma:internalName="lcf76f155ced4ddcb4097134ff3c332f" ma:taxonomyFieldName="MediaServiceImageTags" ma:displayName="Image Tags" ma:readOnly="false" ma:fieldId="{5cf76f15-5ced-4ddc-b409-7134ff3c332f}" ma:taxonomyMulti="true" ma:sspId="7306b285-ac2c-4225-b56d-e54690cf9c9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2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22793d5-3ed3-4929-8744-ffb85abedb4b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dbe73721-18ff-471f-b983-a094a73a5ccd}" ma:internalName="TaxCatchAll" ma:showField="CatchAllData" ma:web="422793d5-3ed3-4929-8744-ffb85abedb4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31A8993-4C8E-47D9-837D-632AF0730071}">
  <ds:schemaRefs>
    <ds:schemaRef ds:uri="http://schemas.microsoft.com/office/2006/metadata/properties"/>
    <ds:schemaRef ds:uri="http://schemas.microsoft.com/office/infopath/2007/PartnerControls"/>
    <ds:schemaRef ds:uri="422793d5-3ed3-4929-8744-ffb85abedb4b"/>
    <ds:schemaRef ds:uri="80a5973c-c1b7-4316-8b87-a29795785b25"/>
  </ds:schemaRefs>
</ds:datastoreItem>
</file>

<file path=customXml/itemProps2.xml><?xml version="1.0" encoding="utf-8"?>
<ds:datastoreItem xmlns:ds="http://schemas.openxmlformats.org/officeDocument/2006/customXml" ds:itemID="{0FF69939-346F-4861-8889-110434863CA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0a5973c-c1b7-4316-8b87-a29795785b25"/>
    <ds:schemaRef ds:uri="422793d5-3ed3-4929-8744-ffb85abedb4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645EB7D4-0061-4279-BBFB-93B4B003386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63</TotalTime>
  <Words>256</Words>
  <Application>Microsoft Office PowerPoint</Application>
  <PresentationFormat>Widescreen</PresentationFormat>
  <Paragraphs>8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Selman</dc:creator>
  <cp:lastModifiedBy>Colin Selman</cp:lastModifiedBy>
  <cp:revision>20</cp:revision>
  <cp:lastPrinted>2023-10-09T13:44:26Z</cp:lastPrinted>
  <dcterms:created xsi:type="dcterms:W3CDTF">2023-08-23T10:50:58Z</dcterms:created>
  <dcterms:modified xsi:type="dcterms:W3CDTF">2023-10-18T19:12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C5E1FE38DA6544EBCD92531E80C1992</vt:lpwstr>
  </property>
</Properties>
</file>